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92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749300"/>
            <a:ext cx="2806700" cy="37433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BE942-E908-4AA3-ACE1-A14A842573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166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-31497" y="1965093"/>
            <a:ext cx="1948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</a:p>
        </p:txBody>
      </p:sp>
      <p:sp>
        <p:nvSpPr>
          <p:cNvPr id="31" name="Rechteck 30"/>
          <p:cNvSpPr/>
          <p:nvPr/>
        </p:nvSpPr>
        <p:spPr>
          <a:xfrm>
            <a:off x="1696124" y="1964531"/>
            <a:ext cx="482107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chez-Mendoza, et al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-α and TLR3 activation-induced depression associated with compromised hippocampal plasticity</a:t>
            </a:r>
          </a:p>
        </p:txBody>
      </p:sp>
      <p:grpSp>
        <p:nvGrpSpPr>
          <p:cNvPr id="17" name="Gruppieren 16"/>
          <p:cNvGrpSpPr/>
          <p:nvPr/>
        </p:nvGrpSpPr>
        <p:grpSpPr>
          <a:xfrm>
            <a:off x="606391" y="2699792"/>
            <a:ext cx="5011995" cy="3452699"/>
            <a:chOff x="292890" y="531250"/>
            <a:chExt cx="6682661" cy="4603597"/>
          </a:xfrm>
        </p:grpSpPr>
        <p:sp>
          <p:nvSpPr>
            <p:cNvPr id="10" name="Textfeld 9"/>
            <p:cNvSpPr txBox="1"/>
            <p:nvPr/>
          </p:nvSpPr>
          <p:spPr>
            <a:xfrm rot="16200000">
              <a:off x="-206789" y="4343658"/>
              <a:ext cx="130537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poly(I:C)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176050" y="559947"/>
              <a:ext cx="870584" cy="32829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NEL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3288285" y="559947"/>
              <a:ext cx="750472" cy="32829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 rot="16200000">
              <a:off x="76769" y="1411181"/>
              <a:ext cx="7184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US" sz="7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 rot="16200000">
              <a:off x="1070" y="2333227"/>
              <a:ext cx="86409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FN-</a:t>
              </a:r>
              <a:r>
                <a:rPr lang="de-DE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US" sz="750" b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-10441" y="3407302"/>
              <a:ext cx="88366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75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</a:t>
              </a:r>
              <a:r>
                <a:rPr lang="de-DE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I:C)</a:t>
              </a:r>
              <a:endParaRPr lang="en-US" sz="7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496531" y="531250"/>
              <a:ext cx="767329" cy="32829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Gruppieren 24"/>
            <p:cNvGrpSpPr/>
            <p:nvPr/>
          </p:nvGrpSpPr>
          <p:grpSpPr>
            <a:xfrm>
              <a:off x="5930204" y="1534055"/>
              <a:ext cx="1024744" cy="633030"/>
              <a:chOff x="6705555" y="1468357"/>
              <a:chExt cx="1024744" cy="633030"/>
            </a:xfrm>
          </p:grpSpPr>
          <p:cxnSp>
            <p:nvCxnSpPr>
              <p:cNvPr id="18" name="Gerade Verbindung mit Pfeil 17"/>
              <p:cNvCxnSpPr/>
              <p:nvPr/>
            </p:nvCxnSpPr>
            <p:spPr>
              <a:xfrm flipV="1">
                <a:off x="7296174" y="1515614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 Verbindung mit Pfeil 27"/>
              <p:cNvCxnSpPr/>
              <p:nvPr/>
            </p:nvCxnSpPr>
            <p:spPr>
              <a:xfrm flipV="1">
                <a:off x="7562023" y="1468357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 Verbindung mit Pfeil 28"/>
              <p:cNvCxnSpPr/>
              <p:nvPr/>
            </p:nvCxnSpPr>
            <p:spPr>
              <a:xfrm>
                <a:off x="6705555" y="2101386"/>
                <a:ext cx="168276" cy="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uppieren 31"/>
            <p:cNvGrpSpPr/>
            <p:nvPr/>
          </p:nvGrpSpPr>
          <p:grpSpPr>
            <a:xfrm>
              <a:off x="5930204" y="2750792"/>
              <a:ext cx="1024744" cy="633030"/>
              <a:chOff x="6705555" y="1468357"/>
              <a:chExt cx="1024744" cy="633030"/>
            </a:xfrm>
          </p:grpSpPr>
          <p:cxnSp>
            <p:nvCxnSpPr>
              <p:cNvPr id="33" name="Gerade Verbindung mit Pfeil 32"/>
              <p:cNvCxnSpPr/>
              <p:nvPr/>
            </p:nvCxnSpPr>
            <p:spPr>
              <a:xfrm flipV="1">
                <a:off x="7296174" y="1515614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Gerade Verbindung mit Pfeil 33"/>
              <p:cNvCxnSpPr/>
              <p:nvPr/>
            </p:nvCxnSpPr>
            <p:spPr>
              <a:xfrm flipV="1">
                <a:off x="7562023" y="1468357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Gerade Verbindung mit Pfeil 34"/>
              <p:cNvCxnSpPr/>
              <p:nvPr/>
            </p:nvCxnSpPr>
            <p:spPr>
              <a:xfrm>
                <a:off x="6705555" y="2101386"/>
                <a:ext cx="168276" cy="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uppieren 35"/>
            <p:cNvGrpSpPr/>
            <p:nvPr/>
          </p:nvGrpSpPr>
          <p:grpSpPr>
            <a:xfrm>
              <a:off x="5887102" y="4139424"/>
              <a:ext cx="1024744" cy="633030"/>
              <a:chOff x="6705555" y="1468357"/>
              <a:chExt cx="1024744" cy="633030"/>
            </a:xfrm>
          </p:grpSpPr>
          <p:cxnSp>
            <p:nvCxnSpPr>
              <p:cNvPr id="37" name="Gerade Verbindung mit Pfeil 36"/>
              <p:cNvCxnSpPr/>
              <p:nvPr/>
            </p:nvCxnSpPr>
            <p:spPr>
              <a:xfrm flipV="1">
                <a:off x="7296174" y="1515614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Gerade Verbindung mit Pfeil 37"/>
              <p:cNvCxnSpPr/>
              <p:nvPr/>
            </p:nvCxnSpPr>
            <p:spPr>
              <a:xfrm flipV="1">
                <a:off x="7562023" y="1468357"/>
                <a:ext cx="168276" cy="945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Gerade Verbindung mit Pfeil 38"/>
              <p:cNvCxnSpPr/>
              <p:nvPr/>
            </p:nvCxnSpPr>
            <p:spPr>
              <a:xfrm>
                <a:off x="6705555" y="2101386"/>
                <a:ext cx="168276" cy="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uppieren 15"/>
            <p:cNvGrpSpPr/>
            <p:nvPr/>
          </p:nvGrpSpPr>
          <p:grpSpPr>
            <a:xfrm>
              <a:off x="621551" y="1035148"/>
              <a:ext cx="6354000" cy="3900206"/>
              <a:chOff x="0" y="622619"/>
              <a:chExt cx="6354000" cy="3900206"/>
            </a:xfrm>
          </p:grpSpPr>
          <p:pic>
            <p:nvPicPr>
              <p:cNvPr id="12" name="Grafik 1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622619"/>
                <a:ext cx="6354000" cy="3900206"/>
              </a:xfrm>
              <a:prstGeom prst="rect">
                <a:avLst/>
              </a:prstGeom>
            </p:spPr>
          </p:pic>
          <p:cxnSp>
            <p:nvCxnSpPr>
              <p:cNvPr id="15" name="Gerader Verbinder 14"/>
              <p:cNvCxnSpPr/>
              <p:nvPr/>
            </p:nvCxnSpPr>
            <p:spPr>
              <a:xfrm>
                <a:off x="5887102" y="4365104"/>
                <a:ext cx="224594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796733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0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3</cp:revision>
  <cp:lastPrinted>2019-03-06T11:43:59Z</cp:lastPrinted>
  <dcterms:created xsi:type="dcterms:W3CDTF">2018-09-05T14:08:24Z</dcterms:created>
  <dcterms:modified xsi:type="dcterms:W3CDTF">2020-05-22T07:20:35Z</dcterms:modified>
</cp:coreProperties>
</file>